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FDFCE3-35A7-4B89-97DC-DA68A5BAED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C3AE370-01B9-41C2-BB46-E4B088EBB5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169CACD-7026-45B0-9C9C-E6677D6EF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BE8D2D4-E15A-4C77-BEC9-16F6DCC203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60DC4F5-83CC-46A6-81F8-7BB384F6E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511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EC3A491-B647-4B2F-AD32-E3E314615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4953D0C-153A-4854-BE5D-5AAF2A00B6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02391C9-6E50-45A8-8926-D80372A23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A32AAC2-4443-48C3-9487-B25F42629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B557114-F41C-49C6-923B-6764FC42E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1580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C375C30-1DBF-4345-8053-CB799B9CB6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4245D30-3E2F-471F-ACE2-432176E843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A21F11C-56EF-43D0-BF18-FD8103281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4741D4D-2D32-43FE-8000-BFB00A641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87BA871-A886-4253-B019-3F92CC988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4855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6B9062C-A762-47E1-AB64-0D796C1A9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CD011A1-3E0C-4366-93F3-CDC58CF914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AA689CB-3035-4D75-9C2C-A2F50E1CF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1DEDEB4-371B-435F-A173-17B2370B7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DFEBF91-DD47-48F8-B1A9-B6F5C887B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3496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FB4E9E-2EFE-4702-A923-796FA2FF0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DFBC56-78D2-4125-83FA-23F8E21DB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D9ACF20-2D2D-46E0-B1D7-C717B5C59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317EA0F-3B3F-41EC-885F-6550E9694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D03F13-3009-4AB1-BEAD-D5C792BDA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3359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DFB98A-D1F1-4B23-9CF0-3ACA7924D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E54A5C7-8619-478A-B0A5-8A1695ED93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5DAF7A2-96B6-460B-BB52-CF32E8340A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57511FD-194B-4736-85F4-149E18667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E056D93-9E07-4CBD-B019-A196E42BF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0CAE299-F02A-4A9C-AEB7-C2A11DD33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5530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FD6FE40-DE86-4E01-841B-FFBD55001B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F8D609-B596-469D-9BED-2CA429E4E9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8572C07-0F11-4FAA-8B1C-A42775FF56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7FE5207A-CA0F-414F-A30D-85AFA9FAB0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3AB30EB-0673-4AFF-B851-D1CD08F42A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F85E8C2-19FB-4695-97CF-4F0BEEB5D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C105976-8A5F-4296-9BCD-9FD8DF426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7734F5F-BF3C-4FEF-B1F2-791F9F74D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4823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BDAE8B-5BD5-4DF9-805A-C4823066A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16BEC9B-D1CF-4659-B113-A6290AAF7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2EDA207-B097-477A-9824-9B3408B86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9ACA379-9BBE-4104-ADC3-07AEDD838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5434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93B4E70-D656-4550-9864-F8A8F9345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9DE601E-63E1-4D52-99EB-6BBA780D4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84C0B57-E130-4637-9418-90C1C9CBC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2926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8C9BADA-C90A-41F1-9B49-5A6D0452E4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602D62A-0FF1-478E-BEEB-8B7D0CFC91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CD8834E-5FCC-41B0-8A3E-50D2DB8BB8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3EE56FB-A2AB-4D1E-ADC0-9DF440244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C5F7965-40C6-40F5-9B56-CA51E61DC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9130AE2-FDE8-4D58-AC2E-EFD9967A5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2233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9B44C9F-D5CD-4406-BD34-C2ABBD529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0BA9559-2FB6-4066-912B-98AC5B1A95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7EC729A-FDC3-44D8-ADB0-05AB067C82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1572CD-2D68-41AA-B08E-D184F6BFD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264B073-AE8F-4310-AC09-0FBAA305C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7BF062A-0510-429F-BBA6-7B53EDE4A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2412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5322979-F7D6-4388-A630-B3FDB84BC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95DA7DB-3DAB-46A9-AF4D-F75E58E67A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DCBCA55-5483-4520-8BF5-3D026FC2FC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11634-4286-40CA-AC67-771A18EBFD5C}" type="datetimeFigureOut">
              <a:rPr lang="it-IT" smtClean="0"/>
              <a:t>08/04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4D135D9-6439-4951-A748-FBDDA495B4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92E72FC-94D2-44E8-A05C-4803BECC39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14523-BEA3-43C5-B2BB-AD346D0F130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4037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A8A352D4-C8C6-4038-8721-70475F3D8597}"/>
              </a:ext>
            </a:extLst>
          </p:cNvPr>
          <p:cNvPicPr/>
          <p:nvPr/>
        </p:nvPicPr>
        <p:blipFill rotWithShape="1">
          <a:blip r:embed="rId2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42"/>
          <a:stretch/>
        </p:blipFill>
        <p:spPr>
          <a:xfrm>
            <a:off x="63132" y="1532708"/>
            <a:ext cx="5780316" cy="3709851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C3C7D689-E0C4-4AA4-9094-A014D1BAA4AF}"/>
              </a:ext>
            </a:extLst>
          </p:cNvPr>
          <p:cNvPicPr/>
          <p:nvPr/>
        </p:nvPicPr>
        <p:blipFill rotWithShape="1">
          <a:blip r:embed="rId3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42"/>
          <a:stretch/>
        </p:blipFill>
        <p:spPr>
          <a:xfrm>
            <a:off x="6035037" y="1532708"/>
            <a:ext cx="5780316" cy="3709852"/>
          </a:xfrm>
          <a:prstGeom prst="rect">
            <a:avLst/>
          </a:prstGeom>
        </p:spPr>
      </p:pic>
      <p:sp>
        <p:nvSpPr>
          <p:cNvPr id="6" name="Rettangolo 5">
            <a:extLst>
              <a:ext uri="{FF2B5EF4-FFF2-40B4-BE49-F238E27FC236}">
                <a16:creationId xmlns:a16="http://schemas.microsoft.com/office/drawing/2014/main" id="{E8B706EF-9585-49B9-A5EA-D05D5DCD298E}"/>
              </a:ext>
            </a:extLst>
          </p:cNvPr>
          <p:cNvSpPr/>
          <p:nvPr/>
        </p:nvSpPr>
        <p:spPr>
          <a:xfrm>
            <a:off x="1863631" y="3857897"/>
            <a:ext cx="836023" cy="357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D971CFCF-7E85-4257-B94F-CA76BE80644A}"/>
              </a:ext>
            </a:extLst>
          </p:cNvPr>
          <p:cNvSpPr/>
          <p:nvPr/>
        </p:nvSpPr>
        <p:spPr>
          <a:xfrm>
            <a:off x="7763706" y="3870957"/>
            <a:ext cx="836023" cy="357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BC3B52A3-B46C-48A1-9095-B78554499D75}"/>
              </a:ext>
            </a:extLst>
          </p:cNvPr>
          <p:cNvSpPr txBox="1"/>
          <p:nvPr/>
        </p:nvSpPr>
        <p:spPr>
          <a:xfrm>
            <a:off x="1863631" y="3805643"/>
            <a:ext cx="129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/>
              <a:t>Normal</a:t>
            </a:r>
            <a:r>
              <a:rPr lang="it-IT" sz="1200" dirty="0"/>
              <a:t> LFT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55AD5A1D-462B-41A3-A2D6-85B5AFE14627}"/>
              </a:ext>
            </a:extLst>
          </p:cNvPr>
          <p:cNvSpPr txBox="1"/>
          <p:nvPr/>
        </p:nvSpPr>
        <p:spPr>
          <a:xfrm>
            <a:off x="1876691" y="3992879"/>
            <a:ext cx="129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/>
              <a:t>Altered</a:t>
            </a:r>
            <a:r>
              <a:rPr lang="it-IT" sz="1200" dirty="0"/>
              <a:t> LFT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0B8FB2A-A0CB-48A5-B752-58ADB57EB96D}"/>
              </a:ext>
            </a:extLst>
          </p:cNvPr>
          <p:cNvSpPr txBox="1"/>
          <p:nvPr/>
        </p:nvSpPr>
        <p:spPr>
          <a:xfrm>
            <a:off x="7798535" y="3792578"/>
            <a:ext cx="129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/>
              <a:t>Normal</a:t>
            </a:r>
            <a:r>
              <a:rPr lang="it-IT" sz="1200" dirty="0"/>
              <a:t> LFT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BAD7AB33-26E3-4400-B8C1-8F3ED0FE33DB}"/>
              </a:ext>
            </a:extLst>
          </p:cNvPr>
          <p:cNvSpPr txBox="1"/>
          <p:nvPr/>
        </p:nvSpPr>
        <p:spPr>
          <a:xfrm>
            <a:off x="7811595" y="3979814"/>
            <a:ext cx="129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/>
              <a:t>Altered</a:t>
            </a:r>
            <a:r>
              <a:rPr lang="it-IT" sz="1200" dirty="0"/>
              <a:t> LFT</a:t>
            </a:r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6C0B778C-F7AC-4548-8A14-F350C18787E1}"/>
              </a:ext>
            </a:extLst>
          </p:cNvPr>
          <p:cNvSpPr/>
          <p:nvPr/>
        </p:nvSpPr>
        <p:spPr>
          <a:xfrm>
            <a:off x="226420" y="4807131"/>
            <a:ext cx="940526" cy="3222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Rettangolo 12">
            <a:extLst>
              <a:ext uri="{FF2B5EF4-FFF2-40B4-BE49-F238E27FC236}">
                <a16:creationId xmlns:a16="http://schemas.microsoft.com/office/drawing/2014/main" id="{ABFB6906-8D0A-4273-A49C-2F4F275587E1}"/>
              </a:ext>
            </a:extLst>
          </p:cNvPr>
          <p:cNvSpPr/>
          <p:nvPr/>
        </p:nvSpPr>
        <p:spPr>
          <a:xfrm>
            <a:off x="6126491" y="4802773"/>
            <a:ext cx="940526" cy="3222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9F8A41E-0C45-4E3E-B790-533BA5B9A6EE}"/>
              </a:ext>
            </a:extLst>
          </p:cNvPr>
          <p:cNvSpPr txBox="1"/>
          <p:nvPr/>
        </p:nvSpPr>
        <p:spPr>
          <a:xfrm>
            <a:off x="448490" y="4750519"/>
            <a:ext cx="12975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err="1"/>
              <a:t>Normal</a:t>
            </a:r>
            <a:r>
              <a:rPr lang="it-IT" sz="900" dirty="0"/>
              <a:t> LFT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07289B2A-402B-4FD1-A3E5-BE42ADE12585}"/>
              </a:ext>
            </a:extLst>
          </p:cNvPr>
          <p:cNvSpPr txBox="1"/>
          <p:nvPr/>
        </p:nvSpPr>
        <p:spPr>
          <a:xfrm>
            <a:off x="444134" y="4885501"/>
            <a:ext cx="12975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err="1"/>
              <a:t>Altered</a:t>
            </a:r>
            <a:r>
              <a:rPr lang="it-IT" sz="900" dirty="0"/>
              <a:t> LFT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0CCF153-6EC6-412B-966A-A4761CC18393}"/>
              </a:ext>
            </a:extLst>
          </p:cNvPr>
          <p:cNvSpPr txBox="1"/>
          <p:nvPr/>
        </p:nvSpPr>
        <p:spPr>
          <a:xfrm>
            <a:off x="6357266" y="4763580"/>
            <a:ext cx="12975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err="1"/>
              <a:t>Normal</a:t>
            </a:r>
            <a:r>
              <a:rPr lang="it-IT" sz="900" dirty="0"/>
              <a:t> LFT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7601A234-990B-4778-80B1-7B0A591805C2}"/>
              </a:ext>
            </a:extLst>
          </p:cNvPr>
          <p:cNvSpPr txBox="1"/>
          <p:nvPr/>
        </p:nvSpPr>
        <p:spPr>
          <a:xfrm>
            <a:off x="6352910" y="4898562"/>
            <a:ext cx="12975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err="1"/>
              <a:t>Altered</a:t>
            </a:r>
            <a:r>
              <a:rPr lang="it-IT" sz="900" dirty="0"/>
              <a:t> LFT</a:t>
            </a:r>
          </a:p>
        </p:txBody>
      </p:sp>
    </p:spTree>
    <p:extLst>
      <p:ext uri="{BB962C8B-B14F-4D97-AF65-F5344CB8AC3E}">
        <p14:creationId xmlns:p14="http://schemas.microsoft.com/office/powerpoint/2010/main" val="24714163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6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Vincenzo Lenti</dc:creator>
  <cp:lastModifiedBy>Marco Vincenzo Lenti</cp:lastModifiedBy>
  <cp:revision>2</cp:revision>
  <dcterms:created xsi:type="dcterms:W3CDTF">2020-04-08T09:48:29Z</dcterms:created>
  <dcterms:modified xsi:type="dcterms:W3CDTF">2020-04-08T10:03:06Z</dcterms:modified>
</cp:coreProperties>
</file>